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AA00"/>
    <a:srgbClr val="003969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11FF0AF-2735-4F21-AFA5-BA543A22142F}" v="13" dt="2024-03-14T10:16:48.51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59" autoAdjust="0"/>
    <p:restoredTop sz="94660"/>
  </p:normalViewPr>
  <p:slideViewPr>
    <p:cSldViewPr snapToGrid="0">
      <p:cViewPr varScale="1">
        <p:scale>
          <a:sx n="82" d="100"/>
          <a:sy n="82" d="100"/>
        </p:scale>
        <p:origin x="89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A11FF0AF-2735-4F21-AFA5-BA543A22142F}"/>
    <pc:docChg chg="undo custSel modSld">
      <pc:chgData name="Laycock, Joseph" userId="c4bfcbf4-3ccc-440e-b317-559baf184f0d" providerId="ADAL" clId="{A11FF0AF-2735-4F21-AFA5-BA543A22142F}" dt="2024-03-14T10:35:56.984" v="406" actId="14100"/>
      <pc:docMkLst>
        <pc:docMk/>
      </pc:docMkLst>
      <pc:sldChg chg="addSp modSp mod">
        <pc:chgData name="Laycock, Joseph" userId="c4bfcbf4-3ccc-440e-b317-559baf184f0d" providerId="ADAL" clId="{A11FF0AF-2735-4F21-AFA5-BA543A22142F}" dt="2024-03-14T10:35:56.984" v="406" actId="14100"/>
        <pc:sldMkLst>
          <pc:docMk/>
          <pc:sldMk cId="2867428870" sldId="268"/>
        </pc:sldMkLst>
        <pc:spChg chg="mod">
          <ac:chgData name="Laycock, Joseph" userId="c4bfcbf4-3ccc-440e-b317-559baf184f0d" providerId="ADAL" clId="{A11FF0AF-2735-4F21-AFA5-BA543A22142F}" dt="2024-03-12T11:59:45.627" v="36" actId="20577"/>
          <ac:spMkLst>
            <pc:docMk/>
            <pc:sldMk cId="2867428870" sldId="268"/>
            <ac:spMk id="3" creationId="{228B6892-1648-DF62-E831-66BF54B0FEA3}"/>
          </ac:spMkLst>
        </pc:spChg>
        <pc:spChg chg="mod">
          <ac:chgData name="Laycock, Joseph" userId="c4bfcbf4-3ccc-440e-b317-559baf184f0d" providerId="ADAL" clId="{A11FF0AF-2735-4F21-AFA5-BA543A22142F}" dt="2024-03-12T11:59:39.048" v="34" actId="20577"/>
          <ac:spMkLst>
            <pc:docMk/>
            <pc:sldMk cId="2867428870" sldId="268"/>
            <ac:spMk id="5" creationId="{A80C6002-7C3F-D901-2E37-E725207AAA1E}"/>
          </ac:spMkLst>
        </pc:spChg>
        <pc:spChg chg="mod">
          <ac:chgData name="Laycock, Joseph" userId="c4bfcbf4-3ccc-440e-b317-559baf184f0d" providerId="ADAL" clId="{A11FF0AF-2735-4F21-AFA5-BA543A22142F}" dt="2024-03-12T12:00:37.095" v="42" actId="14100"/>
          <ac:spMkLst>
            <pc:docMk/>
            <pc:sldMk cId="2867428870" sldId="268"/>
            <ac:spMk id="6" creationId="{A7D8B74F-E6D1-9E52-9D66-BB2127F9D94A}"/>
          </ac:spMkLst>
        </pc:spChg>
        <pc:spChg chg="add mod">
          <ac:chgData name="Laycock, Joseph" userId="c4bfcbf4-3ccc-440e-b317-559baf184f0d" providerId="ADAL" clId="{A11FF0AF-2735-4F21-AFA5-BA543A22142F}" dt="2024-03-14T10:35:52.444" v="405" actId="14100"/>
          <ac:spMkLst>
            <pc:docMk/>
            <pc:sldMk cId="2867428870" sldId="268"/>
            <ac:spMk id="9" creationId="{D881C261-5DD5-AE81-6AFC-14B639BCEA94}"/>
          </ac:spMkLst>
        </pc:spChg>
        <pc:spChg chg="add mod">
          <ac:chgData name="Laycock, Joseph" userId="c4bfcbf4-3ccc-440e-b317-559baf184f0d" providerId="ADAL" clId="{A11FF0AF-2735-4F21-AFA5-BA543A22142F}" dt="2024-03-13T09:43:22.384" v="240" actId="1037"/>
          <ac:spMkLst>
            <pc:docMk/>
            <pc:sldMk cId="2867428870" sldId="268"/>
            <ac:spMk id="10" creationId="{45426AE2-0170-408B-1D6E-BBF9E4AFAFD8}"/>
          </ac:spMkLst>
        </pc:spChg>
        <pc:spChg chg="add mod">
          <ac:chgData name="Laycock, Joseph" userId="c4bfcbf4-3ccc-440e-b317-559baf184f0d" providerId="ADAL" clId="{A11FF0AF-2735-4F21-AFA5-BA543A22142F}" dt="2024-03-13T09:43:22.384" v="240" actId="1037"/>
          <ac:spMkLst>
            <pc:docMk/>
            <pc:sldMk cId="2867428870" sldId="268"/>
            <ac:spMk id="11" creationId="{6A3DEF87-C24B-0465-AD76-6142A6BD2839}"/>
          </ac:spMkLst>
        </pc:spChg>
        <pc:spChg chg="add mod">
          <ac:chgData name="Laycock, Joseph" userId="c4bfcbf4-3ccc-440e-b317-559baf184f0d" providerId="ADAL" clId="{A11FF0AF-2735-4F21-AFA5-BA543A22142F}" dt="2024-03-13T09:43:22.384" v="240" actId="1037"/>
          <ac:spMkLst>
            <pc:docMk/>
            <pc:sldMk cId="2867428870" sldId="268"/>
            <ac:spMk id="12" creationId="{4AB836B9-1884-B0D2-8493-8FE8EA508BD8}"/>
          </ac:spMkLst>
        </pc:spChg>
        <pc:spChg chg="add mod">
          <ac:chgData name="Laycock, Joseph" userId="c4bfcbf4-3ccc-440e-b317-559baf184f0d" providerId="ADAL" clId="{A11FF0AF-2735-4F21-AFA5-BA543A22142F}" dt="2024-03-13T09:42:44.843" v="218" actId="1076"/>
          <ac:spMkLst>
            <pc:docMk/>
            <pc:sldMk cId="2867428870" sldId="268"/>
            <ac:spMk id="13" creationId="{10801EA3-D3A2-D48B-199E-A4E020BC324C}"/>
          </ac:spMkLst>
        </pc:spChg>
        <pc:spChg chg="add mod">
          <ac:chgData name="Laycock, Joseph" userId="c4bfcbf4-3ccc-440e-b317-559baf184f0d" providerId="ADAL" clId="{A11FF0AF-2735-4F21-AFA5-BA543A22142F}" dt="2024-03-13T09:42:22.042" v="213" actId="1076"/>
          <ac:spMkLst>
            <pc:docMk/>
            <pc:sldMk cId="2867428870" sldId="268"/>
            <ac:spMk id="14" creationId="{30DF1A46-D627-5F41-5CCC-E4EAEDDD08F7}"/>
          </ac:spMkLst>
        </pc:spChg>
        <pc:spChg chg="add mod">
          <ac:chgData name="Laycock, Joseph" userId="c4bfcbf4-3ccc-440e-b317-559baf184f0d" providerId="ADAL" clId="{A11FF0AF-2735-4F21-AFA5-BA543A22142F}" dt="2024-03-13T09:42:48.744" v="219" actId="1076"/>
          <ac:spMkLst>
            <pc:docMk/>
            <pc:sldMk cId="2867428870" sldId="268"/>
            <ac:spMk id="15" creationId="{3E3E2085-709E-B591-629A-495E1B370B73}"/>
          </ac:spMkLst>
        </pc:spChg>
        <pc:spChg chg="add mod">
          <ac:chgData name="Laycock, Joseph" userId="c4bfcbf4-3ccc-440e-b317-559baf184f0d" providerId="ADAL" clId="{A11FF0AF-2735-4F21-AFA5-BA543A22142F}" dt="2024-03-14T10:35:39.035" v="404" actId="114"/>
          <ac:spMkLst>
            <pc:docMk/>
            <pc:sldMk cId="2867428870" sldId="268"/>
            <ac:spMk id="16" creationId="{A21339FF-1C8F-2557-0CE0-35F30D7B5958}"/>
          </ac:spMkLst>
        </pc:spChg>
        <pc:spChg chg="mod">
          <ac:chgData name="Laycock, Joseph" userId="c4bfcbf4-3ccc-440e-b317-559baf184f0d" providerId="ADAL" clId="{A11FF0AF-2735-4F21-AFA5-BA543A22142F}" dt="2024-03-12T11:58:24.755" v="6" actId="14100"/>
          <ac:spMkLst>
            <pc:docMk/>
            <pc:sldMk cId="2867428870" sldId="268"/>
            <ac:spMk id="24" creationId="{00000000-0000-0000-0000-000000000000}"/>
          </ac:spMkLst>
        </pc:spChg>
        <pc:picChg chg="add mod">
          <ac:chgData name="Laycock, Joseph" userId="c4bfcbf4-3ccc-440e-b317-559baf184f0d" providerId="ADAL" clId="{A11FF0AF-2735-4F21-AFA5-BA543A22142F}" dt="2024-03-14T10:35:56.984" v="406" actId="14100"/>
          <ac:picMkLst>
            <pc:docMk/>
            <pc:sldMk cId="2867428870" sldId="268"/>
            <ac:picMk id="2" creationId="{7F2F6F41-E526-6AC3-E7F4-38DB0CEA9CEA}"/>
          </ac:picMkLst>
        </pc:picChg>
        <pc:picChg chg="add mod modCrop">
          <ac:chgData name="Laycock, Joseph" userId="c4bfcbf4-3ccc-440e-b317-559baf184f0d" providerId="ADAL" clId="{A11FF0AF-2735-4F21-AFA5-BA543A22142F}" dt="2024-03-13T09:43:22.384" v="240" actId="1037"/>
          <ac:picMkLst>
            <pc:docMk/>
            <pc:sldMk cId="2867428870" sldId="268"/>
            <ac:picMk id="4" creationId="{FA47CD60-310A-D23D-561F-24979812E949}"/>
          </ac:picMkLst>
        </pc:picChg>
        <pc:picChg chg="add mod modCrop">
          <ac:chgData name="Laycock, Joseph" userId="c4bfcbf4-3ccc-440e-b317-559baf184f0d" providerId="ADAL" clId="{A11FF0AF-2735-4F21-AFA5-BA543A22142F}" dt="2024-03-13T09:43:22.384" v="240" actId="1037"/>
          <ac:picMkLst>
            <pc:docMk/>
            <pc:sldMk cId="2867428870" sldId="268"/>
            <ac:picMk id="7" creationId="{3F30D5CE-29EA-AFE0-FE59-A4D3C09A258A}"/>
          </ac:picMkLst>
        </pc:picChg>
        <pc:picChg chg="add mod modCrop">
          <ac:chgData name="Laycock, Joseph" userId="c4bfcbf4-3ccc-440e-b317-559baf184f0d" providerId="ADAL" clId="{A11FF0AF-2735-4F21-AFA5-BA543A22142F}" dt="2024-03-13T09:43:22.384" v="240" actId="1037"/>
          <ac:picMkLst>
            <pc:docMk/>
            <pc:sldMk cId="2867428870" sldId="268"/>
            <ac:picMk id="8" creationId="{FD5D3E92-23D3-A6A2-1673-753A56679813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901646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>
              <a:lnSpc>
                <a:spcPct val="110000"/>
              </a:lnSpc>
            </a:pPr>
            <a:r>
              <a:rPr lang="en-GB" sz="2800" b="1" dirty="0">
                <a:solidFill>
                  <a:schemeClr val="bg1"/>
                </a:solidFill>
              </a:rPr>
              <a:t>Utilizing electronic medical records alert to improve documentation of  neonatal acute kidney injur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28B6892-1648-DF62-E831-66BF54B0FEA3}"/>
              </a:ext>
            </a:extLst>
          </p:cNvPr>
          <p:cNvSpPr txBox="1"/>
          <p:nvPr/>
        </p:nvSpPr>
        <p:spPr>
          <a:xfrm>
            <a:off x="254830" y="1158032"/>
            <a:ext cx="12108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QI initiative to improve documentation of neonatal AKI utilizing the EMR-Aler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80C6002-7C3F-D901-2E37-E725207AAA1E}"/>
              </a:ext>
            </a:extLst>
          </p:cNvPr>
          <p:cNvSpPr txBox="1"/>
          <p:nvPr/>
        </p:nvSpPr>
        <p:spPr>
          <a:xfrm>
            <a:off x="7650039" y="568686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Nada &amp; Bagwell,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7D8B74F-E6D1-9E52-9D66-BB2127F9D94A}"/>
              </a:ext>
            </a:extLst>
          </p:cNvPr>
          <p:cNvSpPr txBox="1"/>
          <p:nvPr/>
        </p:nvSpPr>
        <p:spPr>
          <a:xfrm>
            <a:off x="254830" y="5721277"/>
            <a:ext cx="720406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 integration of EMR alert with automated documentation of AKI diagnosis offers an efficient solution for improving neonatal AKI diagnosis, documentation, and improves nephrology follow up.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F2F6F41-E526-6AC3-E7F4-38DB0CEA9C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4914" y="1922571"/>
            <a:ext cx="6974972" cy="3457574"/>
          </a:xfrm>
          <a:prstGeom prst="snip1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A47CD60-310A-D23D-561F-24979812E94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410" t="25629" r="67591" b="45823"/>
          <a:stretch/>
        </p:blipFill>
        <p:spPr>
          <a:xfrm>
            <a:off x="9380510" y="1791636"/>
            <a:ext cx="2460343" cy="110665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F30D5CE-29EA-AFE0-FE59-A4D3C09A258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453" t="25690" r="34549" b="45762"/>
          <a:stretch/>
        </p:blipFill>
        <p:spPr>
          <a:xfrm>
            <a:off x="9380510" y="3042225"/>
            <a:ext cx="2460343" cy="110665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D5D3E92-23D3-A6A2-1673-753A5667981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0384" t="25556" r="1696" b="45897"/>
          <a:stretch/>
        </p:blipFill>
        <p:spPr>
          <a:xfrm>
            <a:off x="9380510" y="4292297"/>
            <a:ext cx="2533758" cy="118365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881C261-5DD5-AE81-6AFC-14B639BCEA94}"/>
              </a:ext>
            </a:extLst>
          </p:cNvPr>
          <p:cNvSpPr txBox="1"/>
          <p:nvPr/>
        </p:nvSpPr>
        <p:spPr>
          <a:xfrm>
            <a:off x="254831" y="1711282"/>
            <a:ext cx="161129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5426AE2-0170-408B-1D6E-BBF9E4AFAFD8}"/>
              </a:ext>
            </a:extLst>
          </p:cNvPr>
          <p:cNvSpPr txBox="1"/>
          <p:nvPr/>
        </p:nvSpPr>
        <p:spPr>
          <a:xfrm>
            <a:off x="8238119" y="2201510"/>
            <a:ext cx="12678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Neonatal AKI Documentation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A3DEF87-C24B-0465-AD76-6142A6BD2839}"/>
              </a:ext>
            </a:extLst>
          </p:cNvPr>
          <p:cNvSpPr txBox="1"/>
          <p:nvPr/>
        </p:nvSpPr>
        <p:spPr>
          <a:xfrm>
            <a:off x="8238119" y="3406557"/>
            <a:ext cx="12678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Neonatal AKI Consults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AB836B9-1884-B0D2-8493-8FE8EA508BD8}"/>
              </a:ext>
            </a:extLst>
          </p:cNvPr>
          <p:cNvSpPr txBox="1"/>
          <p:nvPr/>
        </p:nvSpPr>
        <p:spPr>
          <a:xfrm>
            <a:off x="8238119" y="4611604"/>
            <a:ext cx="12678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Neonatal AKI </a:t>
            </a:r>
            <a:b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linic Referrals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Arrow: Right 12">
            <a:extLst>
              <a:ext uri="{FF2B5EF4-FFF2-40B4-BE49-F238E27FC236}">
                <a16:creationId xmlns:a16="http://schemas.microsoft.com/office/drawing/2014/main" id="{10801EA3-D3A2-D48B-199E-A4E020BC324C}"/>
              </a:ext>
            </a:extLst>
          </p:cNvPr>
          <p:cNvSpPr/>
          <p:nvPr/>
        </p:nvSpPr>
        <p:spPr>
          <a:xfrm rot="16200000">
            <a:off x="7805986" y="2220635"/>
            <a:ext cx="586254" cy="321940"/>
          </a:xfrm>
          <a:prstGeom prst="rightArrow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30DF1A46-D627-5F41-5CCC-E4EAEDDD08F7}"/>
              </a:ext>
            </a:extLst>
          </p:cNvPr>
          <p:cNvSpPr/>
          <p:nvPr/>
        </p:nvSpPr>
        <p:spPr>
          <a:xfrm rot="16200000">
            <a:off x="7805986" y="3414125"/>
            <a:ext cx="586254" cy="321940"/>
          </a:xfrm>
          <a:prstGeom prst="rightArrow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3E3E2085-709E-B591-629A-495E1B370B73}"/>
              </a:ext>
            </a:extLst>
          </p:cNvPr>
          <p:cNvSpPr/>
          <p:nvPr/>
        </p:nvSpPr>
        <p:spPr>
          <a:xfrm rot="16200000">
            <a:off x="7805989" y="4607615"/>
            <a:ext cx="586254" cy="321940"/>
          </a:xfrm>
          <a:prstGeom prst="rightArrow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21339FF-1C8F-2557-0CE0-35F30D7B5958}"/>
              </a:ext>
            </a:extLst>
          </p:cNvPr>
          <p:cNvSpPr txBox="1"/>
          <p:nvPr/>
        </p:nvSpPr>
        <p:spPr>
          <a:xfrm>
            <a:off x="274914" y="5380336"/>
            <a:ext cx="11691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>
                <a:solidFill>
                  <a:srgbClr val="003969"/>
                </a:solidFill>
              </a:rPr>
              <a:t>AKI</a:t>
            </a:r>
            <a:r>
              <a:rPr lang="en-GB" sz="1200" dirty="0">
                <a:solidFill>
                  <a:srgbClr val="003969"/>
                </a:solidFill>
              </a:rPr>
              <a:t>, acute kidney injury; </a:t>
            </a:r>
            <a:r>
              <a:rPr lang="en-GB" sz="1200" i="1" dirty="0">
                <a:solidFill>
                  <a:srgbClr val="003969"/>
                </a:solidFill>
              </a:rPr>
              <a:t>EMR</a:t>
            </a:r>
            <a:r>
              <a:rPr lang="en-GB" sz="1200" dirty="0">
                <a:solidFill>
                  <a:srgbClr val="003969"/>
                </a:solidFill>
              </a:rPr>
              <a:t>, electronic medical record; </a:t>
            </a:r>
            <a:r>
              <a:rPr lang="en-GB" sz="1200" i="1" dirty="0">
                <a:solidFill>
                  <a:srgbClr val="003969"/>
                </a:solidFill>
              </a:rPr>
              <a:t>MDs</a:t>
            </a:r>
            <a:r>
              <a:rPr lang="en-GB" sz="1200" dirty="0">
                <a:solidFill>
                  <a:srgbClr val="003969"/>
                </a:solidFill>
              </a:rPr>
              <a:t>, medical doctors; </a:t>
            </a:r>
            <a:r>
              <a:rPr lang="en-GB" sz="1200" i="1" dirty="0">
                <a:solidFill>
                  <a:srgbClr val="003969"/>
                </a:solidFill>
              </a:rPr>
              <a:t>NPs</a:t>
            </a:r>
            <a:r>
              <a:rPr lang="en-GB" sz="1200" dirty="0">
                <a:solidFill>
                  <a:srgbClr val="003969"/>
                </a:solidFill>
              </a:rPr>
              <a:t>, nurse practitioners; </a:t>
            </a:r>
            <a:r>
              <a:rPr lang="en-GB" sz="1200" i="1" dirty="0">
                <a:solidFill>
                  <a:srgbClr val="003969"/>
                </a:solidFill>
              </a:rPr>
              <a:t>QI</a:t>
            </a:r>
            <a:r>
              <a:rPr lang="en-GB" sz="1200" dirty="0">
                <a:solidFill>
                  <a:srgbClr val="003969"/>
                </a:solidFill>
              </a:rPr>
              <a:t>, quality assurance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23</TotalTime>
  <Words>103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4-03-14T10:36:03Z</dcterms:modified>
</cp:coreProperties>
</file>